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8" r:id="rId1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00DA1CF-D72D-4858-B7B5-678DBEAD7E97}" v="12" dt="2023-06-15T08:24:50.27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3" d="100"/>
          <a:sy n="53" d="100"/>
        </p:scale>
        <p:origin x="643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織田　遥向" userId="af962fe8-9afa-4890-a729-a6bf56fd9e85" providerId="ADAL" clId="{200DA1CF-D72D-4858-B7B5-678DBEAD7E97}"/>
    <pc:docChg chg="undo custSel addSld delSld modSld">
      <pc:chgData name="織田　遥向" userId="af962fe8-9afa-4890-a729-a6bf56fd9e85" providerId="ADAL" clId="{200DA1CF-D72D-4858-B7B5-678DBEAD7E97}" dt="2023-06-17T04:42:47.719" v="501" actId="20577"/>
      <pc:docMkLst>
        <pc:docMk/>
      </pc:docMkLst>
      <pc:sldChg chg="addSp delSp modSp add del mod delAnim">
        <pc:chgData name="織田　遥向" userId="af962fe8-9afa-4890-a729-a6bf56fd9e85" providerId="ADAL" clId="{200DA1CF-D72D-4858-B7B5-678DBEAD7E97}" dt="2023-06-15T08:28:04.445" v="500" actId="47"/>
        <pc:sldMkLst>
          <pc:docMk/>
          <pc:sldMk cId="317828355" sldId="267"/>
        </pc:sldMkLst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2" creationId="{14941969-4649-525C-371E-7976892C9AE8}"/>
          </ac:spMkLst>
        </pc:spChg>
        <pc:spChg chg="add del mod">
          <ac:chgData name="織田　遥向" userId="af962fe8-9afa-4890-a729-a6bf56fd9e85" providerId="ADAL" clId="{200DA1CF-D72D-4858-B7B5-678DBEAD7E97}" dt="2023-06-10T08:00:15.632" v="9"/>
          <ac:spMkLst>
            <pc:docMk/>
            <pc:sldMk cId="317828355" sldId="267"/>
            <ac:spMk id="2" creationId="{32BE5CB9-778F-287C-680D-1AF2EC33D68F}"/>
          </ac:spMkLst>
        </pc:spChg>
        <pc:spChg chg="del mod">
          <ac:chgData name="織田　遥向" userId="af962fe8-9afa-4890-a729-a6bf56fd9e85" providerId="ADAL" clId="{200DA1CF-D72D-4858-B7B5-678DBEAD7E97}" dt="2023-06-15T08:28:02.429" v="499" actId="478"/>
          <ac:spMkLst>
            <pc:docMk/>
            <pc:sldMk cId="317828355" sldId="267"/>
            <ac:spMk id="4" creationId="{0315B2A2-C9D2-A6BE-8A54-BB233AF8992B}"/>
          </ac:spMkLst>
        </pc:spChg>
        <pc:spChg chg="add del mod">
          <ac:chgData name="織田　遥向" userId="af962fe8-9afa-4890-a729-a6bf56fd9e85" providerId="ADAL" clId="{200DA1CF-D72D-4858-B7B5-678DBEAD7E97}" dt="2023-06-10T08:00:15.632" v="9"/>
          <ac:spMkLst>
            <pc:docMk/>
            <pc:sldMk cId="317828355" sldId="267"/>
            <ac:spMk id="5" creationId="{64034C35-445C-9F08-B7FA-160B77E8EAD8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5" creationId="{D4251146-395A-6F0E-7B12-F22A688A2313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6" creationId="{9241E37D-0FA6-6F99-9CD8-803F0E094589}"/>
          </ac:spMkLst>
        </pc:spChg>
        <pc:spChg chg="add del mod">
          <ac:chgData name="織田　遥向" userId="af962fe8-9afa-4890-a729-a6bf56fd9e85" providerId="ADAL" clId="{200DA1CF-D72D-4858-B7B5-678DBEAD7E97}" dt="2023-06-10T08:00:15.632" v="9"/>
          <ac:spMkLst>
            <pc:docMk/>
            <pc:sldMk cId="317828355" sldId="267"/>
            <ac:spMk id="6" creationId="{E94EC806-52B6-5AB9-0988-7B9EB409F13B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7" creationId="{481ECF79-0D06-1231-4C4E-1B1560CCF91F}"/>
          </ac:spMkLst>
        </pc:spChg>
        <pc:spChg chg="add del mod">
          <ac:chgData name="織田　遥向" userId="af962fe8-9afa-4890-a729-a6bf56fd9e85" providerId="ADAL" clId="{200DA1CF-D72D-4858-B7B5-678DBEAD7E97}" dt="2023-06-10T08:00:15.632" v="9"/>
          <ac:spMkLst>
            <pc:docMk/>
            <pc:sldMk cId="317828355" sldId="267"/>
            <ac:spMk id="7" creationId="{49441952-AF6A-DC12-01E6-9F7F5D8E0110}"/>
          </ac:spMkLst>
        </pc:spChg>
        <pc:spChg chg="add del mod">
          <ac:chgData name="織田　遥向" userId="af962fe8-9afa-4890-a729-a6bf56fd9e85" providerId="ADAL" clId="{200DA1CF-D72D-4858-B7B5-678DBEAD7E97}" dt="2023-06-10T08:00:15.632" v="9"/>
          <ac:spMkLst>
            <pc:docMk/>
            <pc:sldMk cId="317828355" sldId="267"/>
            <ac:spMk id="8" creationId="{83CA0D14-81EC-1A88-BEE9-2AD8A922AAB0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8" creationId="{8544A15F-86ED-D49E-D912-C1D3AC58D9E8}"/>
          </ac:spMkLst>
        </pc:spChg>
        <pc:spChg chg="add del mod">
          <ac:chgData name="織田　遥向" userId="af962fe8-9afa-4890-a729-a6bf56fd9e85" providerId="ADAL" clId="{200DA1CF-D72D-4858-B7B5-678DBEAD7E97}" dt="2023-06-10T08:00:15.632" v="9"/>
          <ac:spMkLst>
            <pc:docMk/>
            <pc:sldMk cId="317828355" sldId="267"/>
            <ac:spMk id="9" creationId="{2FF574E0-0C94-ED01-AD81-91626C251038}"/>
          </ac:spMkLst>
        </pc:spChg>
        <pc:spChg chg="mod">
          <ac:chgData name="織田　遥向" userId="af962fe8-9afa-4890-a729-a6bf56fd9e85" providerId="ADAL" clId="{200DA1CF-D72D-4858-B7B5-678DBEAD7E97}" dt="2023-06-15T08:22:53.629" v="428"/>
          <ac:spMkLst>
            <pc:docMk/>
            <pc:sldMk cId="317828355" sldId="267"/>
            <ac:spMk id="10" creationId="{3C84FE9C-9C59-0B10-3C00-28C61B153E2F}"/>
          </ac:spMkLst>
        </pc:spChg>
        <pc:spChg chg="add del mod">
          <ac:chgData name="織田　遥向" userId="af962fe8-9afa-4890-a729-a6bf56fd9e85" providerId="ADAL" clId="{200DA1CF-D72D-4858-B7B5-678DBEAD7E97}" dt="2023-06-10T08:00:15.632" v="9"/>
          <ac:spMkLst>
            <pc:docMk/>
            <pc:sldMk cId="317828355" sldId="267"/>
            <ac:spMk id="10" creationId="{C31B9342-C794-7ECA-79E0-5874E464A844}"/>
          </ac:spMkLst>
        </pc:spChg>
        <pc:spChg chg="add del mod">
          <ac:chgData name="織田　遥向" userId="af962fe8-9afa-4890-a729-a6bf56fd9e85" providerId="ADAL" clId="{200DA1CF-D72D-4858-B7B5-678DBEAD7E97}" dt="2023-06-15T08:22:52.133" v="427" actId="478"/>
          <ac:spMkLst>
            <pc:docMk/>
            <pc:sldMk cId="317828355" sldId="267"/>
            <ac:spMk id="11" creationId="{17BA4110-3DF0-78D2-C8A6-E397F53C07EE}"/>
          </ac:spMkLst>
        </pc:spChg>
        <pc:spChg chg="add del mod">
          <ac:chgData name="織田　遥向" userId="af962fe8-9afa-4890-a729-a6bf56fd9e85" providerId="ADAL" clId="{200DA1CF-D72D-4858-B7B5-678DBEAD7E97}" dt="2023-06-15T08:22:52.133" v="427" actId="478"/>
          <ac:spMkLst>
            <pc:docMk/>
            <pc:sldMk cId="317828355" sldId="267"/>
            <ac:spMk id="12" creationId="{83CB8360-D0F4-CDC2-8A6B-6A4D2B5816EA}"/>
          </ac:spMkLst>
        </pc:spChg>
        <pc:spChg chg="add del mod">
          <ac:chgData name="織田　遥向" userId="af962fe8-9afa-4890-a729-a6bf56fd9e85" providerId="ADAL" clId="{200DA1CF-D72D-4858-B7B5-678DBEAD7E97}" dt="2023-06-15T08:22:52.133" v="427" actId="478"/>
          <ac:spMkLst>
            <pc:docMk/>
            <pc:sldMk cId="317828355" sldId="267"/>
            <ac:spMk id="13" creationId="{E902DE62-94A6-9202-C039-3A28EB1B9568}"/>
          </ac:spMkLst>
        </pc:spChg>
        <pc:spChg chg="add del mod">
          <ac:chgData name="織田　遥向" userId="af962fe8-9afa-4890-a729-a6bf56fd9e85" providerId="ADAL" clId="{200DA1CF-D72D-4858-B7B5-678DBEAD7E97}" dt="2023-06-15T08:22:52.133" v="427" actId="478"/>
          <ac:spMkLst>
            <pc:docMk/>
            <pc:sldMk cId="317828355" sldId="267"/>
            <ac:spMk id="14" creationId="{93BB2F46-EE8D-1B59-6EA0-6CCA685E80A9}"/>
          </ac:spMkLst>
        </pc:spChg>
        <pc:spChg chg="add del mod">
          <ac:chgData name="織田　遥向" userId="af962fe8-9afa-4890-a729-a6bf56fd9e85" providerId="ADAL" clId="{200DA1CF-D72D-4858-B7B5-678DBEAD7E97}" dt="2023-06-15T08:22:52.133" v="427" actId="478"/>
          <ac:spMkLst>
            <pc:docMk/>
            <pc:sldMk cId="317828355" sldId="267"/>
            <ac:spMk id="15" creationId="{51225ACD-27A7-DD11-AC48-84B490FE0AF3}"/>
          </ac:spMkLst>
        </pc:spChg>
        <pc:spChg chg="add del mod">
          <ac:chgData name="織田　遥向" userId="af962fe8-9afa-4890-a729-a6bf56fd9e85" providerId="ADAL" clId="{200DA1CF-D72D-4858-B7B5-678DBEAD7E97}" dt="2023-06-15T08:22:52.133" v="427" actId="478"/>
          <ac:spMkLst>
            <pc:docMk/>
            <pc:sldMk cId="317828355" sldId="267"/>
            <ac:spMk id="16" creationId="{0EEC5632-49F6-0984-1669-071CD9FAFCDE}"/>
          </ac:spMkLst>
        </pc:spChg>
        <pc:spChg chg="add del mod">
          <ac:chgData name="織田　遥向" userId="af962fe8-9afa-4890-a729-a6bf56fd9e85" providerId="ADAL" clId="{200DA1CF-D72D-4858-B7B5-678DBEAD7E97}" dt="2023-06-15T08:22:52.133" v="427" actId="478"/>
          <ac:spMkLst>
            <pc:docMk/>
            <pc:sldMk cId="317828355" sldId="267"/>
            <ac:spMk id="17" creationId="{CCED0B3D-F8F0-F805-890D-068771EAE407}"/>
          </ac:spMkLst>
        </pc:spChg>
        <pc:spChg chg="mod">
          <ac:chgData name="織田　遥向" userId="af962fe8-9afa-4890-a729-a6bf56fd9e85" providerId="ADAL" clId="{200DA1CF-D72D-4858-B7B5-678DBEAD7E97}" dt="2023-06-15T08:22:53.629" v="428"/>
          <ac:spMkLst>
            <pc:docMk/>
            <pc:sldMk cId="317828355" sldId="267"/>
            <ac:spMk id="18" creationId="{233A49BB-D160-0A92-AD64-1C67A3114195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20" creationId="{896CFA59-0707-5ABD-6ED7-6D90A8587B5A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21" creationId="{BBA73D0F-EE94-EBA4-64BE-50FB7265B1B4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25" creationId="{30735F80-AB72-16B9-836F-3B1758A94A69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26" creationId="{E0C36882-2071-DA59-E7BD-18016A8385A1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27" creationId="{5D0E9758-580A-B468-A1AC-66F5590398CA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28" creationId="{98DDB688-EA9E-6477-EC3D-ED47D2ACE9F5}"/>
          </ac:spMkLst>
        </pc:spChg>
        <pc:spChg chg="mod">
          <ac:chgData name="織田　遥向" userId="af962fe8-9afa-4890-a729-a6bf56fd9e85" providerId="ADAL" clId="{200DA1CF-D72D-4858-B7B5-678DBEAD7E97}" dt="2023-06-15T08:22:53.629" v="428"/>
          <ac:spMkLst>
            <pc:docMk/>
            <pc:sldMk cId="317828355" sldId="267"/>
            <ac:spMk id="30" creationId="{8242D4F3-9D98-1CB1-DD60-FA7AFB5A29B5}"/>
          </ac:spMkLst>
        </pc:spChg>
        <pc:spChg chg="mod">
          <ac:chgData name="織田　遥向" userId="af962fe8-9afa-4890-a729-a6bf56fd9e85" providerId="ADAL" clId="{200DA1CF-D72D-4858-B7B5-678DBEAD7E97}" dt="2023-06-15T08:22:53.629" v="428"/>
          <ac:spMkLst>
            <pc:docMk/>
            <pc:sldMk cId="317828355" sldId="267"/>
            <ac:spMk id="31" creationId="{DAB0BB54-22AA-8617-5C28-3F63324FA0F1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33" creationId="{1D64DFBA-FDCA-7E47-64DC-3F18F44C2536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34" creationId="{915EBAB5-E4A4-154D-B145-840E9A782644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36" creationId="{4FA6E1B4-B66C-0D0F-DA7D-F2FF128624A8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37" creationId="{2D981DB2-0A89-A129-3C67-936BE095D24B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40" creationId="{21A3EEFF-2A9C-661B-0745-753F728B9B17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41" creationId="{B6DFA75B-BE64-0B31-B86C-D0463B9C6155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42" creationId="{82DD11B8-D6E5-65F8-9B9A-C57CC8348079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43" creationId="{920FB6B2-004E-C328-49CA-8CB8D2DDEE9D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44" creationId="{20708770-5EAE-FC40-A705-FF0ED63B76AB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45" creationId="{BEF154FC-6E18-98AB-C88E-1DEC810E5737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46" creationId="{AA1905FD-2323-687B-24ED-6AED1E41B53D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47" creationId="{295B6BA7-D7FC-3376-C196-FE2A83B0E3ED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48" creationId="{04584663-1E66-1046-2FCF-E66DFE1690A2}"/>
          </ac:spMkLst>
        </pc:spChg>
        <pc:spChg chg="mod">
          <ac:chgData name="織田　遥向" userId="af962fe8-9afa-4890-a729-a6bf56fd9e85" providerId="ADAL" clId="{200DA1CF-D72D-4858-B7B5-678DBEAD7E97}" dt="2023-06-15T08:22:53.629" v="428"/>
          <ac:spMkLst>
            <pc:docMk/>
            <pc:sldMk cId="317828355" sldId="267"/>
            <ac:spMk id="50" creationId="{65ADB331-FBA5-9B39-463E-21EC8CDD7563}"/>
          </ac:spMkLst>
        </pc:spChg>
        <pc:spChg chg="mod">
          <ac:chgData name="織田　遥向" userId="af962fe8-9afa-4890-a729-a6bf56fd9e85" providerId="ADAL" clId="{200DA1CF-D72D-4858-B7B5-678DBEAD7E97}" dt="2023-06-15T08:22:53.629" v="428"/>
          <ac:spMkLst>
            <pc:docMk/>
            <pc:sldMk cId="317828355" sldId="267"/>
            <ac:spMk id="51" creationId="{C8E2F1D4-79FA-7CDC-B4BA-F4D518913B9C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53" creationId="{0C297B03-A3AA-CE21-0543-277868B7BE59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54" creationId="{17AFC20E-DFC8-4A4B-7EB3-F3C8AB87962D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55" creationId="{998B7B2C-F13E-3BD5-32C4-6BC05851F79A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56" creationId="{656E8841-0E6D-6595-653B-EF8B0388CBA1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57" creationId="{965F2AE8-A1AE-DA69-9537-25F902EFD666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80" creationId="{1D52EEF1-888D-6D8E-509C-3C8650D4A4A1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82" creationId="{76A5C3E9-3EFB-B529-C1C3-265978A788E5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85" creationId="{405A4F93-4EE6-21D6-D696-AAD5E23977D4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86" creationId="{D3ADF878-F548-2E08-D568-92421C32547B}"/>
          </ac:spMkLst>
        </pc:spChg>
        <pc:spChg chg="add del mod">
          <ac:chgData name="織田　遥向" userId="af962fe8-9afa-4890-a729-a6bf56fd9e85" providerId="ADAL" clId="{200DA1CF-D72D-4858-B7B5-678DBEAD7E97}" dt="2023-06-15T08:23:17.496" v="429"/>
          <ac:spMkLst>
            <pc:docMk/>
            <pc:sldMk cId="317828355" sldId="267"/>
            <ac:spMk id="89" creationId="{7BE8E0C3-5604-F352-3784-416F02B70C0A}"/>
          </ac:spMkLst>
        </pc:spChg>
        <pc:grpChg chg="add del mod">
          <ac:chgData name="織田　遥向" userId="af962fe8-9afa-4890-a729-a6bf56fd9e85" providerId="ADAL" clId="{200DA1CF-D72D-4858-B7B5-678DBEAD7E97}" dt="2023-06-15T08:23:17.496" v="429"/>
          <ac:grpSpMkLst>
            <pc:docMk/>
            <pc:sldMk cId="317828355" sldId="267"/>
            <ac:grpSpMk id="9" creationId="{8FD7A6DB-1703-2822-1235-F78B080849FA}"/>
          </ac:grpSpMkLst>
        </pc:grpChg>
        <pc:grpChg chg="add del mod">
          <ac:chgData name="織田　遥向" userId="af962fe8-9afa-4890-a729-a6bf56fd9e85" providerId="ADAL" clId="{200DA1CF-D72D-4858-B7B5-678DBEAD7E97}" dt="2023-06-15T08:23:17.496" v="429"/>
          <ac:grpSpMkLst>
            <pc:docMk/>
            <pc:sldMk cId="317828355" sldId="267"/>
            <ac:grpSpMk id="29" creationId="{5C732111-A34B-B5D7-551F-4D185D053FF9}"/>
          </ac:grpSpMkLst>
        </pc:grpChg>
        <pc:grpChg chg="add del mod">
          <ac:chgData name="織田　遥向" userId="af962fe8-9afa-4890-a729-a6bf56fd9e85" providerId="ADAL" clId="{200DA1CF-D72D-4858-B7B5-678DBEAD7E97}" dt="2023-06-15T08:23:17.496" v="429"/>
          <ac:grpSpMkLst>
            <pc:docMk/>
            <pc:sldMk cId="317828355" sldId="267"/>
            <ac:grpSpMk id="49" creationId="{77DCBE32-CAFE-F0E5-DD30-C9058B937019}"/>
          </ac:grpSpMkLst>
        </pc:grpChg>
        <pc:picChg chg="del">
          <ac:chgData name="織田　遥向" userId="af962fe8-9afa-4890-a729-a6bf56fd9e85" providerId="ADAL" clId="{200DA1CF-D72D-4858-B7B5-678DBEAD7E97}" dt="2023-06-10T07:59:33.492" v="1" actId="478"/>
          <ac:picMkLst>
            <pc:docMk/>
            <pc:sldMk cId="317828355" sldId="267"/>
            <ac:picMk id="3" creationId="{5E0A560E-F50C-6D7A-70F7-6670D638E91B}"/>
          </ac:picMkLst>
        </pc:pic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3" creationId="{AE4E8276-C1D8-DEA1-A787-B741E05198D2}"/>
          </ac:cxnSpMkLst>
        </pc:cxnChg>
        <pc:cxnChg chg="mod">
          <ac:chgData name="織田　遥向" userId="af962fe8-9afa-4890-a729-a6bf56fd9e85" providerId="ADAL" clId="{200DA1CF-D72D-4858-B7B5-678DBEAD7E97}" dt="2023-06-15T08:22:53.629" v="428"/>
          <ac:cxnSpMkLst>
            <pc:docMk/>
            <pc:sldMk cId="317828355" sldId="267"/>
            <ac:cxnSpMk id="19" creationId="{33644B8B-309B-9213-8489-24E0018D56EE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22" creationId="{914F6F9E-15EE-C77C-DD95-369C97371D8A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23" creationId="{6E4D02EA-FC30-07A8-05A7-4E43B3B42607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24" creationId="{223446F4-0F22-EA2B-DAAF-792659AC5BB5}"/>
          </ac:cxnSpMkLst>
        </pc:cxnChg>
        <pc:cxnChg chg="mod">
          <ac:chgData name="織田　遥向" userId="af962fe8-9afa-4890-a729-a6bf56fd9e85" providerId="ADAL" clId="{200DA1CF-D72D-4858-B7B5-678DBEAD7E97}" dt="2023-06-15T08:22:53.629" v="428"/>
          <ac:cxnSpMkLst>
            <pc:docMk/>
            <pc:sldMk cId="317828355" sldId="267"/>
            <ac:cxnSpMk id="32" creationId="{2BE77757-6102-4CBF-67B0-600FBA3FA966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35" creationId="{FAB1EE20-193C-3C11-654E-54C365EDD905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38" creationId="{C09ADD1A-6051-BEE4-7987-05F18D318107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39" creationId="{E792659B-D2FE-BD7A-D2EF-123E5CF79A5D}"/>
          </ac:cxnSpMkLst>
        </pc:cxnChg>
        <pc:cxnChg chg="mod">
          <ac:chgData name="織田　遥向" userId="af962fe8-9afa-4890-a729-a6bf56fd9e85" providerId="ADAL" clId="{200DA1CF-D72D-4858-B7B5-678DBEAD7E97}" dt="2023-06-15T08:22:53.629" v="428"/>
          <ac:cxnSpMkLst>
            <pc:docMk/>
            <pc:sldMk cId="317828355" sldId="267"/>
            <ac:cxnSpMk id="52" creationId="{098920BE-47B6-C463-0A84-4984423416A2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58" creationId="{2B3E6FE7-46E5-C548-9042-6DFB8DC88723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59" creationId="{661CFD66-A1AA-8A92-FE71-A28E8E7EE8D1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0" creationId="{BA52107A-4C0D-5DA1-D670-A90518BBF95F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1" creationId="{9D26C304-C525-633E-9690-F2E42ED3FC76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2" creationId="{B1B3D329-07C3-1420-9129-31D32C6BD84C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3" creationId="{38221F13-E13F-FFF2-B3AD-A86271FC2E5A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4" creationId="{3EACF0F4-F550-A99B-EB15-651BCA134A11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5" creationId="{E1532248-5E17-495C-BD97-B295B5BED80B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6" creationId="{0DC1864F-A7E2-E152-2A9F-7F592A58B68D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7" creationId="{4B7A662A-6AC3-4465-1B8B-58055A4E627B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8" creationId="{A8CDDD59-8AF6-4C09-0CF6-6BFBC7ECF281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69" creationId="{4B73AF04-6C1A-503F-7363-5D75371AB485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0" creationId="{5CD8273D-D3AF-00D9-8286-8F7C7688D6D2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1" creationId="{E7B17604-91BD-13B6-CDF1-1D95845EA443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2" creationId="{8500573E-37BB-38A1-42D1-8D88C9558BD9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3" creationId="{9CD2EB60-B5F3-70D3-BAB8-DECF7AE3308A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4" creationId="{88B684F5-1FC2-EDAF-0030-35D08B39929D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5" creationId="{5310F517-FEBC-0A06-59C2-745A7D974A1A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6" creationId="{41A6CF82-6C18-95A1-9C24-E36F751C2E59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7" creationId="{7DDCD663-52E7-D355-53D1-5F756C6F20AC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8" creationId="{BFA4B3B4-C91A-31E0-24DD-FB4164D4A87B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79" creationId="{B2B27E28-CECD-660A-D6E2-A05D50F3E533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81" creationId="{122E8D63-8FE1-E108-8C0F-32032B95CA42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83" creationId="{E120A49E-BB7E-2772-9DAA-969782C49AF2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84" creationId="{B427D7DA-327E-5DB0-465B-FE39B27C75D0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87" creationId="{303D530E-0C06-3ADA-2231-7D4218BF46B0}"/>
          </ac:cxnSpMkLst>
        </pc:cxnChg>
        <pc:cxnChg chg="add del mod">
          <ac:chgData name="織田　遥向" userId="af962fe8-9afa-4890-a729-a6bf56fd9e85" providerId="ADAL" clId="{200DA1CF-D72D-4858-B7B5-678DBEAD7E97}" dt="2023-06-15T08:23:17.496" v="429"/>
          <ac:cxnSpMkLst>
            <pc:docMk/>
            <pc:sldMk cId="317828355" sldId="267"/>
            <ac:cxnSpMk id="88" creationId="{1AAF8D17-5C6A-DACE-4538-E9C9014ADAAC}"/>
          </ac:cxnSpMkLst>
        </pc:cxnChg>
      </pc:sldChg>
      <pc:sldChg chg="addSp delSp modSp add mod">
        <pc:chgData name="織田　遥向" userId="af962fe8-9afa-4890-a729-a6bf56fd9e85" providerId="ADAL" clId="{200DA1CF-D72D-4858-B7B5-678DBEAD7E97}" dt="2023-06-17T04:42:47.719" v="501" actId="20577"/>
        <pc:sldMkLst>
          <pc:docMk/>
          <pc:sldMk cId="1910162207" sldId="268"/>
        </pc:sldMkLst>
        <pc:spChg chg="mod">
          <ac:chgData name="織田　遥向" userId="af962fe8-9afa-4890-a729-a6bf56fd9e85" providerId="ADAL" clId="{200DA1CF-D72D-4858-B7B5-678DBEAD7E97}" dt="2023-06-17T04:42:47.719" v="501" actId="20577"/>
          <ac:spMkLst>
            <pc:docMk/>
            <pc:sldMk cId="1910162207" sldId="268"/>
            <ac:spMk id="4" creationId="{0315B2A2-C9D2-A6BE-8A54-BB233AF8992B}"/>
          </ac:spMkLst>
        </pc:spChg>
        <pc:spChg chg="del">
          <ac:chgData name="織田　遥向" userId="af962fe8-9afa-4890-a729-a6bf56fd9e85" providerId="ADAL" clId="{200DA1CF-D72D-4858-B7B5-678DBEAD7E97}" dt="2023-06-10T08:04:01.251" v="224" actId="478"/>
          <ac:spMkLst>
            <pc:docMk/>
            <pc:sldMk cId="1910162207" sldId="268"/>
            <ac:spMk id="11" creationId="{17BA4110-3DF0-78D2-C8A6-E397F53C07EE}"/>
          </ac:spMkLst>
        </pc:spChg>
        <pc:spChg chg="del">
          <ac:chgData name="織田　遥向" userId="af962fe8-9afa-4890-a729-a6bf56fd9e85" providerId="ADAL" clId="{200DA1CF-D72D-4858-B7B5-678DBEAD7E97}" dt="2023-06-10T08:04:01.251" v="224" actId="478"/>
          <ac:spMkLst>
            <pc:docMk/>
            <pc:sldMk cId="1910162207" sldId="268"/>
            <ac:spMk id="12" creationId="{83CB8360-D0F4-CDC2-8A6B-6A4D2B5816EA}"/>
          </ac:spMkLst>
        </pc:spChg>
        <pc:spChg chg="del">
          <ac:chgData name="織田　遥向" userId="af962fe8-9afa-4890-a729-a6bf56fd9e85" providerId="ADAL" clId="{200DA1CF-D72D-4858-B7B5-678DBEAD7E97}" dt="2023-06-10T08:04:01.251" v="224" actId="478"/>
          <ac:spMkLst>
            <pc:docMk/>
            <pc:sldMk cId="1910162207" sldId="268"/>
            <ac:spMk id="13" creationId="{E902DE62-94A6-9202-C039-3A28EB1B9568}"/>
          </ac:spMkLst>
        </pc:spChg>
        <pc:spChg chg="del">
          <ac:chgData name="織田　遥向" userId="af962fe8-9afa-4890-a729-a6bf56fd9e85" providerId="ADAL" clId="{200DA1CF-D72D-4858-B7B5-678DBEAD7E97}" dt="2023-06-10T08:04:01.251" v="224" actId="478"/>
          <ac:spMkLst>
            <pc:docMk/>
            <pc:sldMk cId="1910162207" sldId="268"/>
            <ac:spMk id="14" creationId="{93BB2F46-EE8D-1B59-6EA0-6CCA685E80A9}"/>
          </ac:spMkLst>
        </pc:spChg>
        <pc:spChg chg="del">
          <ac:chgData name="織田　遥向" userId="af962fe8-9afa-4890-a729-a6bf56fd9e85" providerId="ADAL" clId="{200DA1CF-D72D-4858-B7B5-678DBEAD7E97}" dt="2023-06-10T08:04:01.251" v="224" actId="478"/>
          <ac:spMkLst>
            <pc:docMk/>
            <pc:sldMk cId="1910162207" sldId="268"/>
            <ac:spMk id="15" creationId="{51225ACD-27A7-DD11-AC48-84B490FE0AF3}"/>
          </ac:spMkLst>
        </pc:spChg>
        <pc:spChg chg="del">
          <ac:chgData name="織田　遥向" userId="af962fe8-9afa-4890-a729-a6bf56fd9e85" providerId="ADAL" clId="{200DA1CF-D72D-4858-B7B5-678DBEAD7E97}" dt="2023-06-10T08:04:01.251" v="224" actId="478"/>
          <ac:spMkLst>
            <pc:docMk/>
            <pc:sldMk cId="1910162207" sldId="268"/>
            <ac:spMk id="16" creationId="{0EEC5632-49F6-0984-1669-071CD9FAFCDE}"/>
          </ac:spMkLst>
        </pc:spChg>
        <pc:spChg chg="del">
          <ac:chgData name="織田　遥向" userId="af962fe8-9afa-4890-a729-a6bf56fd9e85" providerId="ADAL" clId="{200DA1CF-D72D-4858-B7B5-678DBEAD7E97}" dt="2023-06-10T08:04:01.251" v="224" actId="478"/>
          <ac:spMkLst>
            <pc:docMk/>
            <pc:sldMk cId="1910162207" sldId="268"/>
            <ac:spMk id="17" creationId="{CCED0B3D-F8F0-F805-890D-068771EAE407}"/>
          </ac:spMkLst>
        </pc:spChg>
        <pc:picChg chg="add mod">
          <ac:chgData name="織田　遥向" userId="af962fe8-9afa-4890-a729-a6bf56fd9e85" providerId="ADAL" clId="{200DA1CF-D72D-4858-B7B5-678DBEAD7E97}" dt="2023-06-10T08:06:21.009" v="395" actId="1076"/>
          <ac:picMkLst>
            <pc:docMk/>
            <pc:sldMk cId="1910162207" sldId="268"/>
            <ac:picMk id="3" creationId="{D6553170-2794-15B4-49D3-6C04DC73180A}"/>
          </ac:picMkLst>
        </pc:picChg>
        <pc:picChg chg="add mod">
          <ac:chgData name="織田　遥向" userId="af962fe8-9afa-4890-a729-a6bf56fd9e85" providerId="ADAL" clId="{200DA1CF-D72D-4858-B7B5-678DBEAD7E97}" dt="2023-06-10T12:57:39.781" v="414" actId="1076"/>
          <ac:picMkLst>
            <pc:docMk/>
            <pc:sldMk cId="1910162207" sldId="268"/>
            <ac:picMk id="6" creationId="{111E57E7-BC77-BB9E-28C3-3AFE9644CF50}"/>
          </ac:picMkLst>
        </pc:picChg>
        <pc:picChg chg="add mod">
          <ac:chgData name="織田　遥向" userId="af962fe8-9afa-4890-a729-a6bf56fd9e85" providerId="ADAL" clId="{200DA1CF-D72D-4858-B7B5-678DBEAD7E97}" dt="2023-06-10T08:06:41.261" v="402" actId="1076"/>
          <ac:picMkLst>
            <pc:docMk/>
            <pc:sldMk cId="1910162207" sldId="268"/>
            <ac:picMk id="8" creationId="{AE4D5556-2D70-BDB8-8D9D-51B4AA2A2E47}"/>
          </ac:picMkLst>
        </pc:picChg>
      </pc:sldChg>
    </pc:docChg>
  </pc:docChgLst>
  <pc:docChgLst>
    <pc:chgData name="織田　遥向" userId="af962fe8-9afa-4890-a729-a6bf56fd9e85" providerId="ADAL" clId="{A8CDB3F4-1359-426E-94A3-065158A727A1}"/>
    <pc:docChg chg="undo custSel addSld delSld modSld modMainMaster">
      <pc:chgData name="織田　遥向" userId="af962fe8-9afa-4890-a729-a6bf56fd9e85" providerId="ADAL" clId="{A8CDB3F4-1359-426E-94A3-065158A727A1}" dt="2023-03-15T08:47:54.608" v="450" actId="1076"/>
      <pc:docMkLst>
        <pc:docMk/>
      </pc:docMkLst>
      <pc:sldChg chg="modSp new mod">
        <pc:chgData name="織田　遥向" userId="af962fe8-9afa-4890-a729-a6bf56fd9e85" providerId="ADAL" clId="{A8CDB3F4-1359-426E-94A3-065158A727A1}" dt="2023-03-15T08:15:21.098" v="88" actId="20577"/>
        <pc:sldMkLst>
          <pc:docMk/>
          <pc:sldMk cId="2162977375" sldId="256"/>
        </pc:sldMkLst>
        <pc:spChg chg="mod">
          <ac:chgData name="織田　遥向" userId="af962fe8-9afa-4890-a729-a6bf56fd9e85" providerId="ADAL" clId="{A8CDB3F4-1359-426E-94A3-065158A727A1}" dt="2023-03-15T08:15:21.098" v="88" actId="20577"/>
          <ac:spMkLst>
            <pc:docMk/>
            <pc:sldMk cId="2162977375" sldId="256"/>
            <ac:spMk id="2" creationId="{A4FBA318-2BA9-C452-AB5C-9B033B50EEE4}"/>
          </ac:spMkLst>
        </pc:spChg>
      </pc:sldChg>
      <pc:sldChg chg="addSp delSp modSp new mod delAnim modAnim">
        <pc:chgData name="織田　遥向" userId="af962fe8-9afa-4890-a729-a6bf56fd9e85" providerId="ADAL" clId="{A8CDB3F4-1359-426E-94A3-065158A727A1}" dt="2023-03-15T08:36:51.121" v="281" actId="1076"/>
        <pc:sldMkLst>
          <pc:docMk/>
          <pc:sldMk cId="2757822997" sldId="257"/>
        </pc:sldMkLst>
        <pc:spChg chg="add del mod">
          <ac:chgData name="織田　遥向" userId="af962fe8-9afa-4890-a729-a6bf56fd9e85" providerId="ADAL" clId="{A8CDB3F4-1359-426E-94A3-065158A727A1}" dt="2023-03-15T08:36:11.349" v="269" actId="478"/>
          <ac:spMkLst>
            <pc:docMk/>
            <pc:sldMk cId="2757822997" sldId="257"/>
            <ac:spMk id="3" creationId="{5DD697EB-6E17-58B5-BABB-47733AEE4BDA}"/>
          </ac:spMkLst>
        </pc:spChg>
        <pc:spChg chg="add mod">
          <ac:chgData name="織田　遥向" userId="af962fe8-9afa-4890-a729-a6bf56fd9e85" providerId="ADAL" clId="{A8CDB3F4-1359-426E-94A3-065158A727A1}" dt="2023-03-15T08:24:01.425" v="195" actId="1076"/>
          <ac:spMkLst>
            <pc:docMk/>
            <pc:sldMk cId="2757822997" sldId="257"/>
            <ac:spMk id="4" creationId="{0315B2A2-C9D2-A6BE-8A54-BB233AF8992B}"/>
          </ac:spMkLst>
        </pc:spChg>
        <pc:picChg chg="add del mod modCrop">
          <ac:chgData name="織田　遥向" userId="af962fe8-9afa-4890-a729-a6bf56fd9e85" providerId="ADAL" clId="{A8CDB3F4-1359-426E-94A3-065158A727A1}" dt="2023-03-15T08:36:16.676" v="271" actId="478"/>
          <ac:picMkLst>
            <pc:docMk/>
            <pc:sldMk cId="2757822997" sldId="257"/>
            <ac:picMk id="2" creationId="{2C61978A-940C-3C20-7F2C-8B801D773B09}"/>
          </ac:picMkLst>
        </pc:picChg>
        <pc:picChg chg="add mod">
          <ac:chgData name="織田　遥向" userId="af962fe8-9afa-4890-a729-a6bf56fd9e85" providerId="ADAL" clId="{A8CDB3F4-1359-426E-94A3-065158A727A1}" dt="2023-03-15T08:36:51.121" v="281" actId="1076"/>
          <ac:picMkLst>
            <pc:docMk/>
            <pc:sldMk cId="2757822997" sldId="257"/>
            <ac:picMk id="5" creationId="{2F290502-CB9A-6177-B31B-620AE8B55242}"/>
          </ac:picMkLst>
        </pc:picChg>
      </pc:sldChg>
      <pc:sldChg chg="add del">
        <pc:chgData name="織田　遥向" userId="af962fe8-9afa-4890-a729-a6bf56fd9e85" providerId="ADAL" clId="{A8CDB3F4-1359-426E-94A3-065158A727A1}" dt="2023-03-15T08:19:39.252" v="122" actId="47"/>
        <pc:sldMkLst>
          <pc:docMk/>
          <pc:sldMk cId="562792713" sldId="258"/>
        </pc:sldMkLst>
      </pc:sldChg>
      <pc:sldChg chg="addSp delSp modSp add mod addAnim delAnim modAnim">
        <pc:chgData name="織田　遥向" userId="af962fe8-9afa-4890-a729-a6bf56fd9e85" providerId="ADAL" clId="{A8CDB3F4-1359-426E-94A3-065158A727A1}" dt="2023-03-15T08:46:36.838" v="441" actId="1076"/>
        <pc:sldMkLst>
          <pc:docMk/>
          <pc:sldMk cId="2635925305" sldId="258"/>
        </pc:sldMkLst>
        <pc:spChg chg="del mod">
          <ac:chgData name="織田　遥向" userId="af962fe8-9afa-4890-a729-a6bf56fd9e85" providerId="ADAL" clId="{A8CDB3F4-1359-426E-94A3-065158A727A1}" dt="2023-03-15T08:26:49.920" v="223" actId="478"/>
          <ac:spMkLst>
            <pc:docMk/>
            <pc:sldMk cId="2635925305" sldId="258"/>
            <ac:spMk id="3" creationId="{5DD697EB-6E17-58B5-BABB-47733AEE4BDA}"/>
          </ac:spMkLst>
        </pc:spChg>
        <pc:spChg chg="mod">
          <ac:chgData name="織田　遥向" userId="af962fe8-9afa-4890-a729-a6bf56fd9e85" providerId="ADAL" clId="{A8CDB3F4-1359-426E-94A3-065158A727A1}" dt="2023-03-15T08:27:02.928" v="228" actId="20577"/>
          <ac:spMkLst>
            <pc:docMk/>
            <pc:sldMk cId="2635925305" sldId="258"/>
            <ac:spMk id="4" creationId="{0315B2A2-C9D2-A6BE-8A54-BB233AF8992B}"/>
          </ac:spMkLst>
        </pc:spChg>
        <pc:picChg chg="add mod">
          <ac:chgData name="織田　遥向" userId="af962fe8-9afa-4890-a729-a6bf56fd9e85" providerId="ADAL" clId="{A8CDB3F4-1359-426E-94A3-065158A727A1}" dt="2023-03-15T08:46:36.838" v="441" actId="1076"/>
          <ac:picMkLst>
            <pc:docMk/>
            <pc:sldMk cId="2635925305" sldId="258"/>
            <ac:picMk id="2" creationId="{02746720-E075-7B04-29E0-EE93535D0197}"/>
          </ac:picMkLst>
        </pc:picChg>
        <pc:picChg chg="add del mod">
          <ac:chgData name="織田　遥向" userId="af962fe8-9afa-4890-a729-a6bf56fd9e85" providerId="ADAL" clId="{A8CDB3F4-1359-426E-94A3-065158A727A1}" dt="2023-03-15T08:26:45.266" v="221" actId="478"/>
          <ac:picMkLst>
            <pc:docMk/>
            <pc:sldMk cId="2635925305" sldId="258"/>
            <ac:picMk id="2" creationId="{2C61978A-940C-3C20-7F2C-8B801D773B09}"/>
          </ac:picMkLst>
        </pc:picChg>
        <pc:picChg chg="add del mod ord modCrop">
          <ac:chgData name="織田　遥向" userId="af962fe8-9afa-4890-a729-a6bf56fd9e85" providerId="ADAL" clId="{A8CDB3F4-1359-426E-94A3-065158A727A1}" dt="2023-03-15T08:36:19.575" v="273" actId="478"/>
          <ac:picMkLst>
            <pc:docMk/>
            <pc:sldMk cId="2635925305" sldId="258"/>
            <ac:picMk id="5" creationId="{2C1C8C8D-812A-8F78-94C4-A1144EC52D74}"/>
          </ac:picMkLst>
        </pc:picChg>
      </pc:sldChg>
      <pc:sldChg chg="add del">
        <pc:chgData name="織田　遥向" userId="af962fe8-9afa-4890-a729-a6bf56fd9e85" providerId="ADAL" clId="{A8CDB3F4-1359-426E-94A3-065158A727A1}" dt="2023-03-15T08:19:39.252" v="122" actId="47"/>
        <pc:sldMkLst>
          <pc:docMk/>
          <pc:sldMk cId="137949883" sldId="259"/>
        </pc:sldMkLst>
      </pc:sldChg>
      <pc:sldChg chg="addSp delSp modSp add mod delAnim modAnim">
        <pc:chgData name="織田　遥向" userId="af962fe8-9afa-4890-a729-a6bf56fd9e85" providerId="ADAL" clId="{A8CDB3F4-1359-426E-94A3-065158A727A1}" dt="2023-03-15T08:46:56.001" v="443" actId="1076"/>
        <pc:sldMkLst>
          <pc:docMk/>
          <pc:sldMk cId="2300143550" sldId="259"/>
        </pc:sldMkLst>
        <pc:spChg chg="del mod">
          <ac:chgData name="織田　遥向" userId="af962fe8-9afa-4890-a729-a6bf56fd9e85" providerId="ADAL" clId="{A8CDB3F4-1359-426E-94A3-065158A727A1}" dt="2023-03-15T08:28:57.941" v="247" actId="478"/>
          <ac:spMkLst>
            <pc:docMk/>
            <pc:sldMk cId="2300143550" sldId="259"/>
            <ac:spMk id="3" creationId="{5DD697EB-6E17-58B5-BABB-47733AEE4BDA}"/>
          </ac:spMkLst>
        </pc:spChg>
        <pc:spChg chg="mod">
          <ac:chgData name="織田　遥向" userId="af962fe8-9afa-4890-a729-a6bf56fd9e85" providerId="ADAL" clId="{A8CDB3F4-1359-426E-94A3-065158A727A1}" dt="2023-03-15T08:29:02.753" v="249" actId="20577"/>
          <ac:spMkLst>
            <pc:docMk/>
            <pc:sldMk cId="2300143550" sldId="259"/>
            <ac:spMk id="4" creationId="{0315B2A2-C9D2-A6BE-8A54-BB233AF8992B}"/>
          </ac:spMkLst>
        </pc:spChg>
        <pc:picChg chg="add mod">
          <ac:chgData name="織田　遥向" userId="af962fe8-9afa-4890-a729-a6bf56fd9e85" providerId="ADAL" clId="{A8CDB3F4-1359-426E-94A3-065158A727A1}" dt="2023-03-15T08:46:56.001" v="443" actId="1076"/>
          <ac:picMkLst>
            <pc:docMk/>
            <pc:sldMk cId="2300143550" sldId="259"/>
            <ac:picMk id="2" creationId="{0D7909D4-EF99-4638-0359-6B5EC3FB3EB1}"/>
          </ac:picMkLst>
        </pc:picChg>
        <pc:picChg chg="del">
          <ac:chgData name="織田　遥向" userId="af962fe8-9afa-4890-a729-a6bf56fd9e85" providerId="ADAL" clId="{A8CDB3F4-1359-426E-94A3-065158A727A1}" dt="2023-03-15T08:28:49.675" v="245" actId="478"/>
          <ac:picMkLst>
            <pc:docMk/>
            <pc:sldMk cId="2300143550" sldId="259"/>
            <ac:picMk id="2" creationId="{2C61978A-940C-3C20-7F2C-8B801D773B09}"/>
          </ac:picMkLst>
        </pc:picChg>
        <pc:picChg chg="add del mod ord modCrop">
          <ac:chgData name="織田　遥向" userId="af962fe8-9afa-4890-a729-a6bf56fd9e85" providerId="ADAL" clId="{A8CDB3F4-1359-426E-94A3-065158A727A1}" dt="2023-03-15T08:36:23.050" v="275" actId="478"/>
          <ac:picMkLst>
            <pc:docMk/>
            <pc:sldMk cId="2300143550" sldId="259"/>
            <ac:picMk id="5" creationId="{0BADEF34-6892-8DC3-0ADC-221403D8060C}"/>
          </ac:picMkLst>
        </pc:picChg>
      </pc:sldChg>
      <pc:sldChg chg="addSp delSp modSp add mod delAnim modAnim">
        <pc:chgData name="織田　遥向" userId="af962fe8-9afa-4890-a729-a6bf56fd9e85" providerId="ADAL" clId="{A8CDB3F4-1359-426E-94A3-065158A727A1}" dt="2023-03-15T08:47:03.626" v="445" actId="1076"/>
        <pc:sldMkLst>
          <pc:docMk/>
          <pc:sldMk cId="3061581248" sldId="260"/>
        </pc:sldMkLst>
        <pc:spChg chg="del mod">
          <ac:chgData name="織田　遥向" userId="af962fe8-9afa-4890-a729-a6bf56fd9e85" providerId="ADAL" clId="{A8CDB3F4-1359-426E-94A3-065158A727A1}" dt="2023-03-15T08:30:53.408" v="266" actId="478"/>
          <ac:spMkLst>
            <pc:docMk/>
            <pc:sldMk cId="3061581248" sldId="260"/>
            <ac:spMk id="3" creationId="{5DD697EB-6E17-58B5-BABB-47733AEE4BDA}"/>
          </ac:spMkLst>
        </pc:spChg>
        <pc:spChg chg="mod">
          <ac:chgData name="織田　遥向" userId="af962fe8-9afa-4890-a729-a6bf56fd9e85" providerId="ADAL" clId="{A8CDB3F4-1359-426E-94A3-065158A727A1}" dt="2023-03-15T08:31:33.449" v="268" actId="20577"/>
          <ac:spMkLst>
            <pc:docMk/>
            <pc:sldMk cId="3061581248" sldId="260"/>
            <ac:spMk id="4" creationId="{0315B2A2-C9D2-A6BE-8A54-BB233AF8992B}"/>
          </ac:spMkLst>
        </pc:spChg>
        <pc:picChg chg="del">
          <ac:chgData name="織田　遥向" userId="af962fe8-9afa-4890-a729-a6bf56fd9e85" providerId="ADAL" clId="{A8CDB3F4-1359-426E-94A3-065158A727A1}" dt="2023-03-15T08:30:45.376" v="264" actId="478"/>
          <ac:picMkLst>
            <pc:docMk/>
            <pc:sldMk cId="3061581248" sldId="260"/>
            <ac:picMk id="2" creationId="{2C61978A-940C-3C20-7F2C-8B801D773B09}"/>
          </ac:picMkLst>
        </pc:picChg>
        <pc:picChg chg="add mod">
          <ac:chgData name="織田　遥向" userId="af962fe8-9afa-4890-a729-a6bf56fd9e85" providerId="ADAL" clId="{A8CDB3F4-1359-426E-94A3-065158A727A1}" dt="2023-03-15T08:47:03.626" v="445" actId="1076"/>
          <ac:picMkLst>
            <pc:docMk/>
            <pc:sldMk cId="3061581248" sldId="260"/>
            <ac:picMk id="2" creationId="{7837894E-DACA-CE11-7FBF-8619935F6BD7}"/>
          </ac:picMkLst>
        </pc:picChg>
        <pc:picChg chg="add del mod ord modCrop">
          <ac:chgData name="織田　遥向" userId="af962fe8-9afa-4890-a729-a6bf56fd9e85" providerId="ADAL" clId="{A8CDB3F4-1359-426E-94A3-065158A727A1}" dt="2023-03-15T08:36:26.697" v="277" actId="478"/>
          <ac:picMkLst>
            <pc:docMk/>
            <pc:sldMk cId="3061581248" sldId="260"/>
            <ac:picMk id="5" creationId="{0E9AE006-2456-5324-56A7-17EC9DF5B18F}"/>
          </ac:picMkLst>
        </pc:picChg>
      </pc:sldChg>
      <pc:sldChg chg="add del">
        <pc:chgData name="織田　遥向" userId="af962fe8-9afa-4890-a729-a6bf56fd9e85" providerId="ADAL" clId="{A8CDB3F4-1359-426E-94A3-065158A727A1}" dt="2023-03-15T08:19:39.252" v="122" actId="47"/>
        <pc:sldMkLst>
          <pc:docMk/>
          <pc:sldMk cId="4251721392" sldId="260"/>
        </pc:sldMkLst>
      </pc:sldChg>
      <pc:sldChg chg="addSp delSp modSp add mod delAnim modAnim">
        <pc:chgData name="織田　遥向" userId="af962fe8-9afa-4890-a729-a6bf56fd9e85" providerId="ADAL" clId="{A8CDB3F4-1359-426E-94A3-065158A727A1}" dt="2023-03-15T08:47:08.168" v="446" actId="1076"/>
        <pc:sldMkLst>
          <pc:docMk/>
          <pc:sldMk cId="2583606074" sldId="261"/>
        </pc:sldMkLst>
        <pc:spChg chg="mod">
          <ac:chgData name="織田　遥向" userId="af962fe8-9afa-4890-a729-a6bf56fd9e85" providerId="ADAL" clId="{A8CDB3F4-1359-426E-94A3-065158A727A1}" dt="2023-03-15T08:39:03.991" v="309" actId="20577"/>
          <ac:spMkLst>
            <pc:docMk/>
            <pc:sldMk cId="2583606074" sldId="261"/>
            <ac:spMk id="4" creationId="{0315B2A2-C9D2-A6BE-8A54-BB233AF8992B}"/>
          </ac:spMkLst>
        </pc:spChg>
        <pc:picChg chg="del">
          <ac:chgData name="織田　遥向" userId="af962fe8-9afa-4890-a729-a6bf56fd9e85" providerId="ADAL" clId="{A8CDB3F4-1359-426E-94A3-065158A727A1}" dt="2023-03-15T08:38:16.801" v="296" actId="478"/>
          <ac:picMkLst>
            <pc:docMk/>
            <pc:sldMk cId="2583606074" sldId="261"/>
            <ac:picMk id="2" creationId="{7837894E-DACA-CE11-7FBF-8619935F6BD7}"/>
          </ac:picMkLst>
        </pc:picChg>
        <pc:picChg chg="add mod">
          <ac:chgData name="織田　遥向" userId="af962fe8-9afa-4890-a729-a6bf56fd9e85" providerId="ADAL" clId="{A8CDB3F4-1359-426E-94A3-065158A727A1}" dt="2023-03-15T08:47:08.168" v="446" actId="1076"/>
          <ac:picMkLst>
            <pc:docMk/>
            <pc:sldMk cId="2583606074" sldId="261"/>
            <ac:picMk id="3" creationId="{702836BF-0213-3CCB-0894-A0C0A45308B6}"/>
          </ac:picMkLst>
        </pc:picChg>
      </pc:sldChg>
      <pc:sldChg chg="add del">
        <pc:chgData name="織田　遥向" userId="af962fe8-9afa-4890-a729-a6bf56fd9e85" providerId="ADAL" clId="{A8CDB3F4-1359-426E-94A3-065158A727A1}" dt="2023-03-15T08:19:39.252" v="122" actId="47"/>
        <pc:sldMkLst>
          <pc:docMk/>
          <pc:sldMk cId="4214717696" sldId="261"/>
        </pc:sldMkLst>
      </pc:sldChg>
      <pc:sldChg chg="addSp delSp modSp add mod delAnim modAnim">
        <pc:chgData name="織田　遥向" userId="af962fe8-9afa-4890-a729-a6bf56fd9e85" providerId="ADAL" clId="{A8CDB3F4-1359-426E-94A3-065158A727A1}" dt="2023-03-15T08:45:32.947" v="439" actId="1076"/>
        <pc:sldMkLst>
          <pc:docMk/>
          <pc:sldMk cId="2800935490" sldId="262"/>
        </pc:sldMkLst>
        <pc:spChg chg="mod">
          <ac:chgData name="織田　遥向" userId="af962fe8-9afa-4890-a729-a6bf56fd9e85" providerId="ADAL" clId="{A8CDB3F4-1359-426E-94A3-065158A727A1}" dt="2023-03-15T08:40:18.582" v="324" actId="14100"/>
          <ac:spMkLst>
            <pc:docMk/>
            <pc:sldMk cId="2800935490" sldId="262"/>
            <ac:spMk id="4" creationId="{0315B2A2-C9D2-A6BE-8A54-BB233AF8992B}"/>
          </ac:spMkLst>
        </pc:spChg>
        <pc:picChg chg="add mod">
          <ac:chgData name="織田　遥向" userId="af962fe8-9afa-4890-a729-a6bf56fd9e85" providerId="ADAL" clId="{A8CDB3F4-1359-426E-94A3-065158A727A1}" dt="2023-03-15T08:45:32.947" v="439" actId="1076"/>
          <ac:picMkLst>
            <pc:docMk/>
            <pc:sldMk cId="2800935490" sldId="262"/>
            <ac:picMk id="2" creationId="{C77CC8B8-5C49-FE55-C960-BD5C07B5F9C0}"/>
          </ac:picMkLst>
        </pc:picChg>
        <pc:picChg chg="del">
          <ac:chgData name="織田　遥向" userId="af962fe8-9afa-4890-a729-a6bf56fd9e85" providerId="ADAL" clId="{A8CDB3F4-1359-426E-94A3-065158A727A1}" dt="2023-03-15T08:39:14.558" v="311" actId="478"/>
          <ac:picMkLst>
            <pc:docMk/>
            <pc:sldMk cId="2800935490" sldId="262"/>
            <ac:picMk id="3" creationId="{702836BF-0213-3CCB-0894-A0C0A45308B6}"/>
          </ac:picMkLst>
        </pc:picChg>
      </pc:sldChg>
      <pc:sldChg chg="add del">
        <pc:chgData name="織田　遥向" userId="af962fe8-9afa-4890-a729-a6bf56fd9e85" providerId="ADAL" clId="{A8CDB3F4-1359-426E-94A3-065158A727A1}" dt="2023-03-15T08:19:39.252" v="122" actId="47"/>
        <pc:sldMkLst>
          <pc:docMk/>
          <pc:sldMk cId="4094793185" sldId="262"/>
        </pc:sldMkLst>
      </pc:sldChg>
      <pc:sldChg chg="addSp delSp modSp add mod delAnim modAnim">
        <pc:chgData name="織田　遥向" userId="af962fe8-9afa-4890-a729-a6bf56fd9e85" providerId="ADAL" clId="{A8CDB3F4-1359-426E-94A3-065158A727A1}" dt="2023-03-15T08:47:20.115" v="447" actId="1076"/>
        <pc:sldMkLst>
          <pc:docMk/>
          <pc:sldMk cId="175898996" sldId="263"/>
        </pc:sldMkLst>
        <pc:spChg chg="mod">
          <ac:chgData name="織田　遥向" userId="af962fe8-9afa-4890-a729-a6bf56fd9e85" providerId="ADAL" clId="{A8CDB3F4-1359-426E-94A3-065158A727A1}" dt="2023-03-15T08:41:04.654" v="339" actId="20577"/>
          <ac:spMkLst>
            <pc:docMk/>
            <pc:sldMk cId="175898996" sldId="263"/>
            <ac:spMk id="4" creationId="{0315B2A2-C9D2-A6BE-8A54-BB233AF8992B}"/>
          </ac:spMkLst>
        </pc:spChg>
        <pc:picChg chg="del mod">
          <ac:chgData name="織田　遥向" userId="af962fe8-9afa-4890-a729-a6bf56fd9e85" providerId="ADAL" clId="{A8CDB3F4-1359-426E-94A3-065158A727A1}" dt="2023-03-15T08:40:24.701" v="327" actId="478"/>
          <ac:picMkLst>
            <pc:docMk/>
            <pc:sldMk cId="175898996" sldId="263"/>
            <ac:picMk id="2" creationId="{C77CC8B8-5C49-FE55-C960-BD5C07B5F9C0}"/>
          </ac:picMkLst>
        </pc:picChg>
        <pc:picChg chg="add mod">
          <ac:chgData name="織田　遥向" userId="af962fe8-9afa-4890-a729-a6bf56fd9e85" providerId="ADAL" clId="{A8CDB3F4-1359-426E-94A3-065158A727A1}" dt="2023-03-15T08:47:20.115" v="447" actId="1076"/>
          <ac:picMkLst>
            <pc:docMk/>
            <pc:sldMk cId="175898996" sldId="263"/>
            <ac:picMk id="3" creationId="{5DBFC99C-3121-1326-BA03-BED6716F1E5B}"/>
          </ac:picMkLst>
        </pc:picChg>
      </pc:sldChg>
      <pc:sldChg chg="add del">
        <pc:chgData name="織田　遥向" userId="af962fe8-9afa-4890-a729-a6bf56fd9e85" providerId="ADAL" clId="{A8CDB3F4-1359-426E-94A3-065158A727A1}" dt="2023-03-15T08:19:39.252" v="122" actId="47"/>
        <pc:sldMkLst>
          <pc:docMk/>
          <pc:sldMk cId="3764439211" sldId="263"/>
        </pc:sldMkLst>
      </pc:sldChg>
      <pc:sldChg chg="add del">
        <pc:chgData name="織田　遥向" userId="af962fe8-9afa-4890-a729-a6bf56fd9e85" providerId="ADAL" clId="{A8CDB3F4-1359-426E-94A3-065158A727A1}" dt="2023-03-15T08:19:39.252" v="122" actId="47"/>
        <pc:sldMkLst>
          <pc:docMk/>
          <pc:sldMk cId="442187916" sldId="264"/>
        </pc:sldMkLst>
      </pc:sldChg>
      <pc:sldChg chg="addSp delSp modSp add mod delAnim modAnim">
        <pc:chgData name="織田　遥向" userId="af962fe8-9afa-4890-a729-a6bf56fd9e85" providerId="ADAL" clId="{A8CDB3F4-1359-426E-94A3-065158A727A1}" dt="2023-03-15T08:47:25.350" v="448" actId="1076"/>
        <pc:sldMkLst>
          <pc:docMk/>
          <pc:sldMk cId="2090937093" sldId="264"/>
        </pc:sldMkLst>
        <pc:spChg chg="mod">
          <ac:chgData name="織田　遥向" userId="af962fe8-9afa-4890-a729-a6bf56fd9e85" providerId="ADAL" clId="{A8CDB3F4-1359-426E-94A3-065158A727A1}" dt="2023-03-15T08:42:47.119" v="394" actId="1035"/>
          <ac:spMkLst>
            <pc:docMk/>
            <pc:sldMk cId="2090937093" sldId="264"/>
            <ac:spMk id="4" creationId="{0315B2A2-C9D2-A6BE-8A54-BB233AF8992B}"/>
          </ac:spMkLst>
        </pc:spChg>
        <pc:picChg chg="add mod">
          <ac:chgData name="織田　遥向" userId="af962fe8-9afa-4890-a729-a6bf56fd9e85" providerId="ADAL" clId="{A8CDB3F4-1359-426E-94A3-065158A727A1}" dt="2023-03-15T08:47:25.350" v="448" actId="1076"/>
          <ac:picMkLst>
            <pc:docMk/>
            <pc:sldMk cId="2090937093" sldId="264"/>
            <ac:picMk id="2" creationId="{5278038D-E484-5AE3-AE06-D3E4C60F311B}"/>
          </ac:picMkLst>
        </pc:picChg>
        <pc:picChg chg="del">
          <ac:chgData name="織田　遥向" userId="af962fe8-9afa-4890-a729-a6bf56fd9e85" providerId="ADAL" clId="{A8CDB3F4-1359-426E-94A3-065158A727A1}" dt="2023-03-15T08:41:24.461" v="341" actId="478"/>
          <ac:picMkLst>
            <pc:docMk/>
            <pc:sldMk cId="2090937093" sldId="264"/>
            <ac:picMk id="3" creationId="{5DBFC99C-3121-1326-BA03-BED6716F1E5B}"/>
          </ac:picMkLst>
        </pc:picChg>
      </pc:sldChg>
      <pc:sldChg chg="add del">
        <pc:chgData name="織田　遥向" userId="af962fe8-9afa-4890-a729-a6bf56fd9e85" providerId="ADAL" clId="{A8CDB3F4-1359-426E-94A3-065158A727A1}" dt="2023-03-15T08:19:39.252" v="122" actId="47"/>
        <pc:sldMkLst>
          <pc:docMk/>
          <pc:sldMk cId="2127017334" sldId="265"/>
        </pc:sldMkLst>
      </pc:sldChg>
      <pc:sldChg chg="addSp delSp modSp add mod delAnim modAnim">
        <pc:chgData name="織田　遥向" userId="af962fe8-9afa-4890-a729-a6bf56fd9e85" providerId="ADAL" clId="{A8CDB3F4-1359-426E-94A3-065158A727A1}" dt="2023-03-15T08:43:55.347" v="428" actId="20577"/>
        <pc:sldMkLst>
          <pc:docMk/>
          <pc:sldMk cId="2792365306" sldId="265"/>
        </pc:sldMkLst>
        <pc:spChg chg="mod">
          <ac:chgData name="織田　遥向" userId="af962fe8-9afa-4890-a729-a6bf56fd9e85" providerId="ADAL" clId="{A8CDB3F4-1359-426E-94A3-065158A727A1}" dt="2023-03-15T08:43:55.347" v="428" actId="20577"/>
          <ac:spMkLst>
            <pc:docMk/>
            <pc:sldMk cId="2792365306" sldId="265"/>
            <ac:spMk id="4" creationId="{0315B2A2-C9D2-A6BE-8A54-BB233AF8992B}"/>
          </ac:spMkLst>
        </pc:spChg>
        <pc:picChg chg="add mod">
          <ac:chgData name="織田　遥向" userId="af962fe8-9afa-4890-a729-a6bf56fd9e85" providerId="ADAL" clId="{A8CDB3F4-1359-426E-94A3-065158A727A1}" dt="2023-03-15T08:43:31.207" v="400" actId="1076"/>
          <ac:picMkLst>
            <pc:docMk/>
            <pc:sldMk cId="2792365306" sldId="265"/>
            <ac:picMk id="2" creationId="{67D90FED-9087-4716-1541-3B96B6086CD3}"/>
          </ac:picMkLst>
        </pc:picChg>
        <pc:picChg chg="del">
          <ac:chgData name="織田　遥向" userId="af962fe8-9afa-4890-a729-a6bf56fd9e85" providerId="ADAL" clId="{A8CDB3F4-1359-426E-94A3-065158A727A1}" dt="2023-03-15T08:43:11.226" v="396" actId="478"/>
          <ac:picMkLst>
            <pc:docMk/>
            <pc:sldMk cId="2792365306" sldId="265"/>
            <ac:picMk id="3" creationId="{5DBFC99C-3121-1326-BA03-BED6716F1E5B}"/>
          </ac:picMkLst>
        </pc:picChg>
      </pc:sldChg>
      <pc:sldChg chg="add del">
        <pc:chgData name="織田　遥向" userId="af962fe8-9afa-4890-a729-a6bf56fd9e85" providerId="ADAL" clId="{A8CDB3F4-1359-426E-94A3-065158A727A1}" dt="2023-03-15T08:19:39.252" v="122" actId="47"/>
        <pc:sldMkLst>
          <pc:docMk/>
          <pc:sldMk cId="773699061" sldId="266"/>
        </pc:sldMkLst>
      </pc:sldChg>
      <pc:sldChg chg="addSp delSp modSp add mod delAnim modAnim">
        <pc:chgData name="織田　遥向" userId="af962fe8-9afa-4890-a729-a6bf56fd9e85" providerId="ADAL" clId="{A8CDB3F4-1359-426E-94A3-065158A727A1}" dt="2023-03-15T08:47:54.608" v="450" actId="1076"/>
        <pc:sldMkLst>
          <pc:docMk/>
          <pc:sldMk cId="1250896120" sldId="266"/>
        </pc:sldMkLst>
        <pc:spChg chg="mod">
          <ac:chgData name="織田　遥向" userId="af962fe8-9afa-4890-a729-a6bf56fd9e85" providerId="ADAL" clId="{A8CDB3F4-1359-426E-94A3-065158A727A1}" dt="2023-03-15T08:44:59.045" v="438" actId="20577"/>
          <ac:spMkLst>
            <pc:docMk/>
            <pc:sldMk cId="1250896120" sldId="266"/>
            <ac:spMk id="4" creationId="{0315B2A2-C9D2-A6BE-8A54-BB233AF8992B}"/>
          </ac:spMkLst>
        </pc:spChg>
        <pc:picChg chg="del">
          <ac:chgData name="織田　遥向" userId="af962fe8-9afa-4890-a729-a6bf56fd9e85" providerId="ADAL" clId="{A8CDB3F4-1359-426E-94A3-065158A727A1}" dt="2023-03-15T08:44:24.966" v="432" actId="478"/>
          <ac:picMkLst>
            <pc:docMk/>
            <pc:sldMk cId="1250896120" sldId="266"/>
            <ac:picMk id="2" creationId="{67D90FED-9087-4716-1541-3B96B6086CD3}"/>
          </ac:picMkLst>
        </pc:picChg>
        <pc:picChg chg="add mod">
          <ac:chgData name="織田　遥向" userId="af962fe8-9afa-4890-a729-a6bf56fd9e85" providerId="ADAL" clId="{A8CDB3F4-1359-426E-94A3-065158A727A1}" dt="2023-03-15T08:47:54.608" v="450" actId="1076"/>
          <ac:picMkLst>
            <pc:docMk/>
            <pc:sldMk cId="1250896120" sldId="266"/>
            <ac:picMk id="3" creationId="{5E0A560E-F50C-6D7A-70F7-6670D638E91B}"/>
          </ac:picMkLst>
        </pc:picChg>
      </pc:sldChg>
      <pc:sldMasterChg chg="modSp modSldLayout">
        <pc:chgData name="織田　遥向" userId="af962fe8-9afa-4890-a729-a6bf56fd9e85" providerId="ADAL" clId="{A8CDB3F4-1359-426E-94A3-065158A727A1}" dt="2023-03-15T08:13:23.632" v="1"/>
        <pc:sldMasterMkLst>
          <pc:docMk/>
          <pc:sldMasterMk cId="1647488483" sldId="2147483648"/>
        </pc:sldMasterMkLst>
        <pc:spChg chg="mod">
          <ac:chgData name="織田　遥向" userId="af962fe8-9afa-4890-a729-a6bf56fd9e85" providerId="ADAL" clId="{A8CDB3F4-1359-426E-94A3-065158A727A1}" dt="2023-03-15T08:13:23.632" v="1"/>
          <ac:spMkLst>
            <pc:docMk/>
            <pc:sldMasterMk cId="1647488483" sldId="2147483648"/>
            <ac:spMk id="2" creationId="{DFE83D2D-B675-99C2-1494-17CA19EE4744}"/>
          </ac:spMkLst>
        </pc:spChg>
        <pc:spChg chg="mod">
          <ac:chgData name="織田　遥向" userId="af962fe8-9afa-4890-a729-a6bf56fd9e85" providerId="ADAL" clId="{A8CDB3F4-1359-426E-94A3-065158A727A1}" dt="2023-03-15T08:13:23.632" v="1"/>
          <ac:spMkLst>
            <pc:docMk/>
            <pc:sldMasterMk cId="1647488483" sldId="2147483648"/>
            <ac:spMk id="3" creationId="{493212A3-E466-8757-DC82-51117ACA28BA}"/>
          </ac:spMkLst>
        </pc:spChg>
        <pc:spChg chg="mod">
          <ac:chgData name="織田　遥向" userId="af962fe8-9afa-4890-a729-a6bf56fd9e85" providerId="ADAL" clId="{A8CDB3F4-1359-426E-94A3-065158A727A1}" dt="2023-03-15T08:13:23.632" v="1"/>
          <ac:spMkLst>
            <pc:docMk/>
            <pc:sldMasterMk cId="1647488483" sldId="2147483648"/>
            <ac:spMk id="4" creationId="{64B1DAD9-48DF-BE99-AF59-8D34D0F90BB6}"/>
          </ac:spMkLst>
        </pc:spChg>
        <pc:spChg chg="mod">
          <ac:chgData name="織田　遥向" userId="af962fe8-9afa-4890-a729-a6bf56fd9e85" providerId="ADAL" clId="{A8CDB3F4-1359-426E-94A3-065158A727A1}" dt="2023-03-15T08:13:23.632" v="1"/>
          <ac:spMkLst>
            <pc:docMk/>
            <pc:sldMasterMk cId="1647488483" sldId="2147483648"/>
            <ac:spMk id="5" creationId="{D1E2BA23-A4A0-C156-835F-1F14F2D8D7AF}"/>
          </ac:spMkLst>
        </pc:spChg>
        <pc:spChg chg="mod">
          <ac:chgData name="織田　遥向" userId="af962fe8-9afa-4890-a729-a6bf56fd9e85" providerId="ADAL" clId="{A8CDB3F4-1359-426E-94A3-065158A727A1}" dt="2023-03-15T08:13:23.632" v="1"/>
          <ac:spMkLst>
            <pc:docMk/>
            <pc:sldMasterMk cId="1647488483" sldId="2147483648"/>
            <ac:spMk id="6" creationId="{A972FB07-14BF-BA5F-00E4-BF68FCFDDDAB}"/>
          </ac:spMkLst>
        </pc:spChg>
        <pc:sldLayoutChg chg="modSp">
          <pc:chgData name="織田　遥向" userId="af962fe8-9afa-4890-a729-a6bf56fd9e85" providerId="ADAL" clId="{A8CDB3F4-1359-426E-94A3-065158A727A1}" dt="2023-03-15T08:13:23.632" v="1"/>
          <pc:sldLayoutMkLst>
            <pc:docMk/>
            <pc:sldMasterMk cId="1647488483" sldId="2147483648"/>
            <pc:sldLayoutMk cId="2492657491" sldId="2147483649"/>
          </pc:sldLayoutMkLst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2492657491" sldId="2147483649"/>
              <ac:spMk id="2" creationId="{79424F86-7A2B-E041-55B0-21B7513820A3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2492657491" sldId="2147483649"/>
              <ac:spMk id="3" creationId="{537311C9-5355-F6EA-F680-206B86A2FC5C}"/>
            </ac:spMkLst>
          </pc:spChg>
        </pc:sldLayoutChg>
        <pc:sldLayoutChg chg="modSp">
          <pc:chgData name="織田　遥向" userId="af962fe8-9afa-4890-a729-a6bf56fd9e85" providerId="ADAL" clId="{A8CDB3F4-1359-426E-94A3-065158A727A1}" dt="2023-03-15T08:13:23.632" v="1"/>
          <pc:sldLayoutMkLst>
            <pc:docMk/>
            <pc:sldMasterMk cId="1647488483" sldId="2147483648"/>
            <pc:sldLayoutMk cId="3691834416" sldId="2147483651"/>
          </pc:sldLayoutMkLst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3691834416" sldId="2147483651"/>
              <ac:spMk id="2" creationId="{16B51A24-FFAB-61A4-AC30-466BA6C99DDF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3691834416" sldId="2147483651"/>
              <ac:spMk id="3" creationId="{32950FEE-F433-B27E-0929-DE4675E4A09D}"/>
            </ac:spMkLst>
          </pc:spChg>
        </pc:sldLayoutChg>
        <pc:sldLayoutChg chg="modSp">
          <pc:chgData name="織田　遥向" userId="af962fe8-9afa-4890-a729-a6bf56fd9e85" providerId="ADAL" clId="{A8CDB3F4-1359-426E-94A3-065158A727A1}" dt="2023-03-15T08:13:23.632" v="1"/>
          <pc:sldLayoutMkLst>
            <pc:docMk/>
            <pc:sldMasterMk cId="1647488483" sldId="2147483648"/>
            <pc:sldLayoutMk cId="3503624165" sldId="2147483652"/>
          </pc:sldLayoutMkLst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3503624165" sldId="2147483652"/>
              <ac:spMk id="3" creationId="{ABBD5188-CAC6-E927-EA27-061274AE8F4C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3503624165" sldId="2147483652"/>
              <ac:spMk id="4" creationId="{6F0FC59E-D69F-651E-6440-9D23268AC2EE}"/>
            </ac:spMkLst>
          </pc:spChg>
        </pc:sldLayoutChg>
        <pc:sldLayoutChg chg="modSp">
          <pc:chgData name="織田　遥向" userId="af962fe8-9afa-4890-a729-a6bf56fd9e85" providerId="ADAL" clId="{A8CDB3F4-1359-426E-94A3-065158A727A1}" dt="2023-03-15T08:13:23.632" v="1"/>
          <pc:sldLayoutMkLst>
            <pc:docMk/>
            <pc:sldMasterMk cId="1647488483" sldId="2147483648"/>
            <pc:sldLayoutMk cId="640705727" sldId="2147483653"/>
          </pc:sldLayoutMkLst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640705727" sldId="2147483653"/>
              <ac:spMk id="2" creationId="{EA7A8997-8B4F-03E1-4AA7-44CF12E2407B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640705727" sldId="2147483653"/>
              <ac:spMk id="3" creationId="{B42B2091-9913-00F3-D911-DB88CF88F1FA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640705727" sldId="2147483653"/>
              <ac:spMk id="4" creationId="{ECD29C74-4E0B-18BB-EA14-D44527C7A86F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640705727" sldId="2147483653"/>
              <ac:spMk id="5" creationId="{5500C15E-296C-A482-E145-62903FA55B17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640705727" sldId="2147483653"/>
              <ac:spMk id="6" creationId="{9D6828A0-0174-A853-EF6C-3FFF74AF5BD7}"/>
            </ac:spMkLst>
          </pc:spChg>
        </pc:sldLayoutChg>
        <pc:sldLayoutChg chg="modSp">
          <pc:chgData name="織田　遥向" userId="af962fe8-9afa-4890-a729-a6bf56fd9e85" providerId="ADAL" clId="{A8CDB3F4-1359-426E-94A3-065158A727A1}" dt="2023-03-15T08:13:23.632" v="1"/>
          <pc:sldLayoutMkLst>
            <pc:docMk/>
            <pc:sldMasterMk cId="1647488483" sldId="2147483648"/>
            <pc:sldLayoutMk cId="4186176151" sldId="2147483656"/>
          </pc:sldLayoutMkLst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4186176151" sldId="2147483656"/>
              <ac:spMk id="2" creationId="{1D48DB76-18CE-9DFA-255B-E38FB5614535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4186176151" sldId="2147483656"/>
              <ac:spMk id="3" creationId="{4D1A9AA6-EBE6-3243-EB4D-6B5D39018A2D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4186176151" sldId="2147483656"/>
              <ac:spMk id="4" creationId="{C51B26A9-A220-94AB-9AA6-C3CBA0732816}"/>
            </ac:spMkLst>
          </pc:spChg>
        </pc:sldLayoutChg>
        <pc:sldLayoutChg chg="modSp">
          <pc:chgData name="織田　遥向" userId="af962fe8-9afa-4890-a729-a6bf56fd9e85" providerId="ADAL" clId="{A8CDB3F4-1359-426E-94A3-065158A727A1}" dt="2023-03-15T08:13:23.632" v="1"/>
          <pc:sldLayoutMkLst>
            <pc:docMk/>
            <pc:sldMasterMk cId="1647488483" sldId="2147483648"/>
            <pc:sldLayoutMk cId="397037489" sldId="2147483657"/>
          </pc:sldLayoutMkLst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397037489" sldId="2147483657"/>
              <ac:spMk id="2" creationId="{0B2803EE-1E24-8856-0383-4095B7913978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397037489" sldId="2147483657"/>
              <ac:spMk id="3" creationId="{755642F0-8241-8110-60D1-62A8A6FA83C4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397037489" sldId="2147483657"/>
              <ac:spMk id="4" creationId="{9833D26A-88F3-BA32-EA38-B66D7127498B}"/>
            </ac:spMkLst>
          </pc:spChg>
        </pc:sldLayoutChg>
        <pc:sldLayoutChg chg="modSp">
          <pc:chgData name="織田　遥向" userId="af962fe8-9afa-4890-a729-a6bf56fd9e85" providerId="ADAL" clId="{A8CDB3F4-1359-426E-94A3-065158A727A1}" dt="2023-03-15T08:13:23.632" v="1"/>
          <pc:sldLayoutMkLst>
            <pc:docMk/>
            <pc:sldMasterMk cId="1647488483" sldId="2147483648"/>
            <pc:sldLayoutMk cId="833561935" sldId="2147483659"/>
          </pc:sldLayoutMkLst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833561935" sldId="2147483659"/>
              <ac:spMk id="2" creationId="{5255CA5E-12D7-FB1B-588B-5D49A8BF1FE7}"/>
            </ac:spMkLst>
          </pc:spChg>
          <pc:spChg chg="mod">
            <ac:chgData name="織田　遥向" userId="af962fe8-9afa-4890-a729-a6bf56fd9e85" providerId="ADAL" clId="{A8CDB3F4-1359-426E-94A3-065158A727A1}" dt="2023-03-15T08:13:23.632" v="1"/>
            <ac:spMkLst>
              <pc:docMk/>
              <pc:sldMasterMk cId="1647488483" sldId="2147483648"/>
              <pc:sldLayoutMk cId="833561935" sldId="2147483659"/>
              <ac:spMk id="3" creationId="{9449677D-5D30-6B62-B9F4-5D2B229EEE95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424F86-7A2B-E041-55B0-21B7513820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37311C9-5355-F6EA-F680-206B86A2FC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79D3A6-D285-6448-C64F-22EB635F1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CCABAB3-112F-0C82-8CD1-9A54B28CF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47F83B-0BDA-3145-2E1A-5A6C5FFC4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657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58C481-776E-BA1A-FE6F-72506F074E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FA5DEEF-741F-5FB2-FF41-F2B7697972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9ECC0D-D46D-91B3-014C-8B485C122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07963A-6CED-7136-B607-D92AD30A8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FCD7A9-259C-9BA7-4351-85CC5B588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3313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255CA5E-12D7-FB1B-588B-5D49A8BF1F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449677D-5D30-6B62-B9F4-5D2B229EEE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E04D656-B12A-B028-D7FC-464146077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374820-4C35-00E3-63A3-69B150EA6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846303-1388-EC1E-9C3F-EECE290E6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3561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2D5057-7D53-2590-08F8-7340D51D9D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E122722-19AE-42AF-C3B1-1155936034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46FC9B-883F-595F-B78C-C519959DF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EED64B4-BC77-78D8-AC08-6243B0568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27C8FE-3CAC-19BB-F482-EB5CE8FE2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95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B51A24-FFAB-61A4-AC30-466BA6C99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2950FEE-F433-B27E-0929-DE4675E4A0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768F5F-EDBC-01D8-12D9-2254E24BF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AE779B-7CEC-0445-6846-20B6B6D80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B548D2-02CA-9D27-CBD7-140E49EA5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1834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918258-5FE1-C155-E3A4-25254F40C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BBD5188-CAC6-E927-EA27-061274AE8F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F0FC59E-D69F-651E-6440-9D23268AC2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B0D17C9-DC93-A564-9D1A-F785C5D03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31B9FF0-247D-190E-E91A-119A0AD77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1786FDD-A555-5D7C-42B6-C11A7B9DF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3624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7A8997-8B4F-03E1-4AA7-44CF12E240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2B2091-9913-00F3-D911-DB88CF88F1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CD29C74-4E0B-18BB-EA14-D44527C7A8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500C15E-296C-A482-E145-62903FA55B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D6828A0-0174-A853-EF6C-3FFF74AF5B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CB6B5CB-1016-B1D8-0CC2-C9BAAA744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069D15F-C11C-6C76-5670-1A0379AA7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02939A9-8C79-4DE8-B509-BDE89126A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0705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5B644C-810A-7BE2-03E8-BDBC83A8D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C41AB0E-4790-BA10-C4EC-0D4B0D6AF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89F5169-0CC3-DEFF-3F46-520F3682D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B8E4249-6756-5654-FB13-9127F0784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3771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6955788-6B35-52E1-B70D-1785A089A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EE4FE68-A0A9-A292-5ADC-D718D44CF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BE62033-0FE5-BA5D-687B-F8FDDC44E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1169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48DB76-18CE-9DFA-255B-E38FB5614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D1A9AA6-EBE6-3243-EB4D-6B5D39018A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51B26A9-A220-94AB-9AA6-C3CBA07328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E3518D1-58B2-7209-2940-8461B38BD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9C2A4D5-1B8C-4D90-F1FF-643003AAD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06E37AB-C817-A121-F8BB-4D53ABA14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6176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2803EE-1E24-8856-0383-4095B7913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55642F0-8241-8110-60D1-62A8A6FA83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833D26A-88F3-BA32-EA38-B66D712749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CB88C9E-5D01-0FD4-B0B4-6DB9AF50D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5A6BE01-14E0-A30F-EA2B-F382C2DF7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DF0F1E4-4EB0-D30A-317B-686697050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037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FE83D2D-B675-99C2-1494-17CA19EE47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93212A3-E466-8757-DC82-51117ACA28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B1DAD9-48DF-BE99-AF59-8D34D0F90B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CCDC4B-BEEA-4CAC-8744-1E9C5CABEA70}" type="datetimeFigureOut">
              <a:rPr kumimoji="1" lang="ja-JP" altLang="en-US" smtClean="0"/>
              <a:t>2023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E2BA23-A4A0-C156-835F-1F14F2D8D7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72FB07-14BF-BA5F-00E4-BF68FCFDDD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6D5665-9FE9-4DB5-A5C2-1E25B66EF7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488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9.mp4"/><Relationship Id="rId1" Type="http://schemas.microsoft.com/office/2007/relationships/media" Target="../media/media9.mp4"/><Relationship Id="rId4" Type="http://schemas.openxmlformats.org/officeDocument/2006/relationships/image" Target="../media/image8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0.mp4"/><Relationship Id="rId1" Type="http://schemas.microsoft.com/office/2007/relationships/media" Target="../media/media10.mp4"/><Relationship Id="rId4" Type="http://schemas.openxmlformats.org/officeDocument/2006/relationships/image" Target="../media/image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hyperlink" Target="https://drive.google.com/drive/folders/1NMxs4Dnh6Nj8zXb4B59GOiNuSKZiz64M?usp=sharing" TargetMode="Externa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6.mp4"/><Relationship Id="rId1" Type="http://schemas.microsoft.com/office/2007/relationships/media" Target="../media/media6.mp4"/><Relationship Id="rId4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7.mp4"/><Relationship Id="rId1" Type="http://schemas.microsoft.com/office/2007/relationships/media" Target="../media/media7.mp4"/><Relationship Id="rId4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8.mp4"/><Relationship Id="rId1" Type="http://schemas.microsoft.com/office/2007/relationships/media" Target="../media/media8.mp4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FBA318-2BA9-C452-AB5C-9B033B50EEE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Materials for</a:t>
            </a:r>
            <a:b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</a:br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Persistent homological</a:t>
            </a:r>
            <a:b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</a:br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cell tracking technology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120D752-AD3F-9BA1-6CBF-1C94244FFF2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97737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86473"/>
            <a:ext cx="66993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9: The result of tracking vascular endothelial cells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2" name="Supplementary_Video_S9">
            <a:hlinkClick r:id="" action="ppaction://media"/>
            <a:extLst>
              <a:ext uri="{FF2B5EF4-FFF2-40B4-BE49-F238E27FC236}">
                <a16:creationId xmlns:a16="http://schemas.microsoft.com/office/drawing/2014/main" id="{67D90FED-9087-4716-1541-3B96B6086CD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92508" y="15151"/>
            <a:ext cx="9406983" cy="6271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236530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86473"/>
            <a:ext cx="66993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10: The result of tracking vascular endothelial cells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3" name="Supplementary_Video_S10">
            <a:hlinkClick r:id="" action="ppaction://media"/>
            <a:extLst>
              <a:ext uri="{FF2B5EF4-FFF2-40B4-BE49-F238E27FC236}">
                <a16:creationId xmlns:a16="http://schemas.microsoft.com/office/drawing/2014/main" id="{5E0A560E-F50C-6D7A-70F7-6670D638E91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443544" y="83199"/>
            <a:ext cx="9304911" cy="6203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08961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334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2568467" y="5330798"/>
            <a:ext cx="705506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Figure</a:t>
            </a:r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 S1: Some of the model images used for the analysis with ground truth. We provide the link for our data.</a:t>
            </a:r>
          </a:p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  <a:hlinkClick r:id="rId2"/>
              </a:rPr>
              <a:t>https://drive.google.com/drive/folders/1NMxs4Dnh6Nj8zXb4B59GOiNuSKZiz64M?usp=sharing</a:t>
            </a:r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 We also have a flowchart of our method in thi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 link.</a:t>
            </a:r>
            <a:endParaRPr kumimoji="1" lang="en-US" altLang="ja-JP" dirty="0">
              <a:latin typeface="Segoe UI" panose="020B0502040204020203" pitchFamily="34" charset="0"/>
              <a:cs typeface="Segoe UI" panose="020B0502040204020203" pitchFamily="34" charset="0"/>
            </a:endParaRPr>
          </a:p>
          <a:p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3" name="Picture 2" descr="A picture containing moon, darkness, black, space&#10;&#10;Description automatically generated">
            <a:extLst>
              <a:ext uri="{FF2B5EF4-FFF2-40B4-BE49-F238E27FC236}">
                <a16:creationId xmlns:a16="http://schemas.microsoft.com/office/drawing/2014/main" id="{D6553170-2794-15B4-49D3-6C04DC73180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1210" y="1226771"/>
            <a:ext cx="3390208" cy="3390208"/>
          </a:xfrm>
          <a:prstGeom prst="rect">
            <a:avLst/>
          </a:prstGeom>
        </p:spPr>
      </p:pic>
      <p:pic>
        <p:nvPicPr>
          <p:cNvPr id="6" name="Picture 5" descr="A picture containing black, darkness, moon, astronomical object&#10;&#10;Description automatically generated">
            <a:extLst>
              <a:ext uri="{FF2B5EF4-FFF2-40B4-BE49-F238E27FC236}">
                <a16:creationId xmlns:a16="http://schemas.microsoft.com/office/drawing/2014/main" id="{111E57E7-BC77-BB9E-28C3-3AFE9644CF5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0896" y="1212484"/>
            <a:ext cx="3390208" cy="3390208"/>
          </a:xfrm>
          <a:prstGeom prst="rect">
            <a:avLst/>
          </a:prstGeom>
        </p:spPr>
      </p:pic>
      <p:pic>
        <p:nvPicPr>
          <p:cNvPr id="8" name="Picture 7" descr="A white dots on a black background&#10;&#10;Description automatically generated with low confidence">
            <a:extLst>
              <a:ext uri="{FF2B5EF4-FFF2-40B4-BE49-F238E27FC236}">
                <a16:creationId xmlns:a16="http://schemas.microsoft.com/office/drawing/2014/main" id="{AE4D5556-2D70-BDB8-8D9D-51B4AA2A2E4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582" y="1226771"/>
            <a:ext cx="3390208" cy="3390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0162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86473"/>
            <a:ext cx="611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1: The result of tracking MDCK cells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5" name="Supplementary_Video_S1">
            <a:hlinkClick r:id="" action="ppaction://media"/>
            <a:extLst>
              <a:ext uri="{FF2B5EF4-FFF2-40B4-BE49-F238E27FC236}">
                <a16:creationId xmlns:a16="http://schemas.microsoft.com/office/drawing/2014/main" id="{2F290502-CB9A-6177-B31B-620AE8B5524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422514" y="55158"/>
            <a:ext cx="9346972" cy="62313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782299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80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86473"/>
            <a:ext cx="611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2 The result of tracking MDCK cells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2" name="Supplementary_Video_S2">
            <a:hlinkClick r:id="" action="ppaction://media"/>
            <a:extLst>
              <a:ext uri="{FF2B5EF4-FFF2-40B4-BE49-F238E27FC236}">
                <a16:creationId xmlns:a16="http://schemas.microsoft.com/office/drawing/2014/main" id="{02746720-E075-7B04-29E0-EE93535D019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0093" y="202195"/>
            <a:ext cx="11431813" cy="6037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9253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86473"/>
            <a:ext cx="611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3: The result of tracking MDCK cells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2" name="Supplementary_Video_S3">
            <a:hlinkClick r:id="" action="ppaction://media"/>
            <a:extLst>
              <a:ext uri="{FF2B5EF4-FFF2-40B4-BE49-F238E27FC236}">
                <a16:creationId xmlns:a16="http://schemas.microsoft.com/office/drawing/2014/main" id="{0D7909D4-EF99-4638-0359-6B5EC3FB3EB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616075" y="202195"/>
            <a:ext cx="8959850" cy="59732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01435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86473"/>
            <a:ext cx="611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4: The result of tracking MDCK cells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2" name="Supplementary_Video_S4">
            <a:hlinkClick r:id="" action="ppaction://media"/>
            <a:extLst>
              <a:ext uri="{FF2B5EF4-FFF2-40B4-BE49-F238E27FC236}">
                <a16:creationId xmlns:a16="http://schemas.microsoft.com/office/drawing/2014/main" id="{7837894E-DACA-CE11-7FBF-8619935F6BD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461294" y="202195"/>
            <a:ext cx="9269412" cy="61796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15812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9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86473"/>
            <a:ext cx="611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5: The result of tracking MS-1 cells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3" name="Supplementary_Video_S5">
            <a:hlinkClick r:id="" action="ppaction://media"/>
            <a:extLst>
              <a:ext uri="{FF2B5EF4-FFF2-40B4-BE49-F238E27FC236}">
                <a16:creationId xmlns:a16="http://schemas.microsoft.com/office/drawing/2014/main" id="{702836BF-0213-3CCB-0894-A0C0A45308B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570037" y="202195"/>
            <a:ext cx="9051925" cy="6034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36060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86473"/>
            <a:ext cx="66993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6: The result of tracking NIH3T3 cells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2" name="Supplementary_Video_S6">
            <a:hlinkClick r:id="" action="ppaction://media"/>
            <a:extLst>
              <a:ext uri="{FF2B5EF4-FFF2-40B4-BE49-F238E27FC236}">
                <a16:creationId xmlns:a16="http://schemas.microsoft.com/office/drawing/2014/main" id="{C77CC8B8-5C49-FE55-C960-BD5C07B5F9C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434208" y="70751"/>
            <a:ext cx="9323583" cy="6215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09354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5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86473"/>
            <a:ext cx="66993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7: The result of tracking Vero cells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3" name="Supplementary_Video_S7">
            <a:hlinkClick r:id="" action="ppaction://media"/>
            <a:extLst>
              <a:ext uri="{FF2B5EF4-FFF2-40B4-BE49-F238E27FC236}">
                <a16:creationId xmlns:a16="http://schemas.microsoft.com/office/drawing/2014/main" id="{5DBFC99C-3121-1326-BA03-BED6716F1E5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653208" y="202195"/>
            <a:ext cx="8885584" cy="5923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8989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315B2A2-C9D2-A6BE-8A54-BB233AF8992B}"/>
              </a:ext>
            </a:extLst>
          </p:cNvPr>
          <p:cNvSpPr txBox="1"/>
          <p:nvPr/>
        </p:nvSpPr>
        <p:spPr>
          <a:xfrm>
            <a:off x="3036277" y="6241869"/>
            <a:ext cx="70332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ementary Video S8: The result of tracking Vero cells. 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We modified the plot in the 10</a:t>
            </a:r>
            <a:r>
              <a:rPr lang="en-US" altLang="ja-JP" baseline="30000" dirty="0">
                <a:latin typeface="Segoe UI" panose="020B0502040204020203" pitchFamily="34" charset="0"/>
                <a:cs typeface="Segoe UI" panose="020B0502040204020203" pitchFamily="34" charset="0"/>
              </a:rPr>
              <a:t>th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 image.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2" name="Supplementary_Video_S8">
            <a:hlinkClick r:id="" action="ppaction://media"/>
            <a:extLst>
              <a:ext uri="{FF2B5EF4-FFF2-40B4-BE49-F238E27FC236}">
                <a16:creationId xmlns:a16="http://schemas.microsoft.com/office/drawing/2014/main" id="{5278038D-E484-5AE3-AE06-D3E4C60F311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443581" y="124178"/>
            <a:ext cx="9304838" cy="6203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09370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184</Words>
  <Application>Microsoft Office PowerPoint</Application>
  <PresentationFormat>Widescreen</PresentationFormat>
  <Paragraphs>13</Paragraphs>
  <Slides>12</Slides>
  <Notes>0</Notes>
  <HiddenSlides>0</HiddenSlides>
  <MMClips>1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游ゴシック</vt:lpstr>
      <vt:lpstr>游ゴシック Light</vt:lpstr>
      <vt:lpstr>Arial</vt:lpstr>
      <vt:lpstr>Segoe UI</vt:lpstr>
      <vt:lpstr>Office テーマ</vt:lpstr>
      <vt:lpstr>Supplementary Materials for Persistent homological cell tracking technology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s for Persistent homological cell tracking technology</dc:title>
  <dc:creator>織田　遥向</dc:creator>
  <cp:lastModifiedBy>織田　遥向</cp:lastModifiedBy>
  <cp:revision>1</cp:revision>
  <dcterms:created xsi:type="dcterms:W3CDTF">2023-03-15T08:12:53Z</dcterms:created>
  <dcterms:modified xsi:type="dcterms:W3CDTF">2023-06-17T04:42:53Z</dcterms:modified>
</cp:coreProperties>
</file>